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-3036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3\SUP.%20FIGURE%2003%20-%20Luc%20Assays%20-%20TARGETS%20REST%20(Averages)%20-%20v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3\SUP.%20FIGURE%2003%20-%20Luc%20Assays%20-%20TARGETS%20REST%20(Averages)%20-%20v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3\SUP.%20FIGURE%2003%20-%20Luc%20Assays%20-%20TARGETS%20REST%20(Averages)%20-%20v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Targets</a:t>
            </a:r>
            <a:r>
              <a:rPr lang="en-US" sz="1200" baseline="0" dirty="0">
                <a:latin typeface="Arial" pitchFamily="34" charset="0"/>
                <a:cs typeface="Arial" pitchFamily="34" charset="0"/>
              </a:rPr>
              <a:t> with Single Binding Site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48h</c:v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D$11,FIGURES!$D$14,FIGURES!$D$17)</c:f>
                <c:numCache>
                  <c:formatCode>General</c:formatCode>
                  <c:ptCount val="3"/>
                  <c:pt idx="0">
                    <c:v>5.0254060353073866</c:v>
                  </c:pt>
                  <c:pt idx="1">
                    <c:v>2.4019036680085342</c:v>
                  </c:pt>
                  <c:pt idx="2">
                    <c:v>1.2490741984359119</c:v>
                  </c:pt>
                </c:numCache>
              </c:numRef>
            </c:plus>
            <c:minus>
              <c:numRef>
                <c:f>(FIGURES!$D$11,FIGURES!$D$14,FIGURES!$D$17)</c:f>
                <c:numCache>
                  <c:formatCode>General</c:formatCode>
                  <c:ptCount val="3"/>
                  <c:pt idx="0">
                    <c:v>5.0254060353073866</c:v>
                  </c:pt>
                  <c:pt idx="1">
                    <c:v>2.4019036680085342</c:v>
                  </c:pt>
                  <c:pt idx="2">
                    <c:v>1.2490741984359119</c:v>
                  </c:pt>
                </c:numCache>
              </c:numRef>
            </c:minus>
          </c:errBars>
          <c:cat>
            <c:strRef>
              <c:f>(FIGURES!$A$10,FIGURES!$A$13,FIGURES!$A$16)</c:f>
              <c:strCache>
                <c:ptCount val="3"/>
                <c:pt idx="0">
                  <c:v>SSRP1</c:v>
                </c:pt>
                <c:pt idx="1">
                  <c:v>PDE3A</c:v>
                </c:pt>
                <c:pt idx="2">
                  <c:v>LIFR</c:v>
                </c:pt>
              </c:strCache>
            </c:strRef>
          </c:cat>
          <c:val>
            <c:numRef>
              <c:f>(FIGURES!$D$10,FIGURES!$D$13,FIGURES!$D$16)</c:f>
              <c:numCache>
                <c:formatCode>0.0</c:formatCode>
                <c:ptCount val="3"/>
                <c:pt idx="0">
                  <c:v>72.09020724353465</c:v>
                </c:pt>
                <c:pt idx="1">
                  <c:v>69.942303099041226</c:v>
                </c:pt>
                <c:pt idx="2">
                  <c:v>60.333496532398428</c:v>
                </c:pt>
              </c:numCache>
            </c:numRef>
          </c:val>
        </c:ser>
        <c:ser>
          <c:idx val="1"/>
          <c:order val="1"/>
          <c:tx>
            <c:v>72h</c:v>
          </c:tx>
          <c:spPr>
            <a:solidFill>
              <a:schemeClr val="tx2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F$11,FIGURES!$F$14,FIGURES!$F$17)</c:f>
                <c:numCache>
                  <c:formatCode>General</c:formatCode>
                  <c:ptCount val="3"/>
                  <c:pt idx="0">
                    <c:v>11.442426095042272</c:v>
                  </c:pt>
                  <c:pt idx="1">
                    <c:v>3.8593187098615132</c:v>
                  </c:pt>
                  <c:pt idx="2">
                    <c:v>3.9828693954110985</c:v>
                  </c:pt>
                </c:numCache>
              </c:numRef>
            </c:plus>
            <c:minus>
              <c:numRef>
                <c:f>(FIGURES!$F$11,FIGURES!$F$14,FIGURES!$F$17)</c:f>
                <c:numCache>
                  <c:formatCode>General</c:formatCode>
                  <c:ptCount val="3"/>
                  <c:pt idx="0">
                    <c:v>11.442426095042272</c:v>
                  </c:pt>
                  <c:pt idx="1">
                    <c:v>3.8593187098615132</c:v>
                  </c:pt>
                  <c:pt idx="2">
                    <c:v>3.9828693954110985</c:v>
                  </c:pt>
                </c:numCache>
              </c:numRef>
            </c:minus>
          </c:errBars>
          <c:cat>
            <c:strRef>
              <c:f>(FIGURES!$A$10,FIGURES!$A$13,FIGURES!$A$16)</c:f>
              <c:strCache>
                <c:ptCount val="3"/>
                <c:pt idx="0">
                  <c:v>SSRP1</c:v>
                </c:pt>
                <c:pt idx="1">
                  <c:v>PDE3A</c:v>
                </c:pt>
                <c:pt idx="2">
                  <c:v>LIFR</c:v>
                </c:pt>
              </c:strCache>
            </c:strRef>
          </c:cat>
          <c:val>
            <c:numRef>
              <c:f>(FIGURES!$F$10,FIGURES!$F$13,FIGURES!$F$16)</c:f>
              <c:numCache>
                <c:formatCode>0.0</c:formatCode>
                <c:ptCount val="3"/>
                <c:pt idx="0">
                  <c:v>73.272726953927858</c:v>
                </c:pt>
                <c:pt idx="1">
                  <c:v>66.841689854089879</c:v>
                </c:pt>
                <c:pt idx="2">
                  <c:v>61.6716871040830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70"/>
        <c:axId val="74692480"/>
        <c:axId val="74694016"/>
      </c:barChart>
      <c:catAx>
        <c:axId val="746924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74694016"/>
        <c:crosses val="autoZero"/>
        <c:auto val="1"/>
        <c:lblAlgn val="ctr"/>
        <c:lblOffset val="100"/>
        <c:noMultiLvlLbl val="0"/>
      </c:catAx>
      <c:valAx>
        <c:axId val="74694016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Luciferase Activity</a:t>
                </a:r>
                <a:r>
                  <a:rPr lang="en-US" sz="800" baseline="0"/>
                  <a:t> </a:t>
                </a:r>
                <a:r>
                  <a:rPr lang="en-US" sz="800"/>
                  <a:t>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74692480"/>
        <c:crosses val="autoZero"/>
        <c:crossBetween val="between"/>
        <c:majorUnit val="20"/>
      </c:valAx>
    </c:plotArea>
    <c:legend>
      <c:legendPos val="t"/>
      <c:layout>
        <c:manualLayout>
          <c:xMode val="edge"/>
          <c:yMode val="edge"/>
          <c:x val="0.41484601924759534"/>
          <c:y val="0.12962962962962879"/>
          <c:w val="0.17586351706036746"/>
          <c:h val="8.3717191601050067E-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Targets</a:t>
            </a:r>
            <a:r>
              <a:rPr lang="en-US" sz="1200" baseline="0" dirty="0">
                <a:latin typeface="Arial" pitchFamily="34" charset="0"/>
                <a:cs typeface="Arial" pitchFamily="34" charset="0"/>
              </a:rPr>
              <a:t> with </a:t>
            </a:r>
            <a:r>
              <a:rPr lang="en-US" sz="1200" baseline="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200" baseline="0" dirty="0">
                <a:latin typeface="Arial" pitchFamily="34" charset="0"/>
                <a:cs typeface="Arial" pitchFamily="34" charset="0"/>
              </a:rPr>
              <a:t>Binding Site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8115211019631391"/>
          <c:y val="0.14560854456735794"/>
          <c:w val="0.77441902178890909"/>
          <c:h val="0.76367070761453715"/>
        </c:manualLayout>
      </c:layout>
      <c:barChart>
        <c:barDir val="col"/>
        <c:grouping val="clustered"/>
        <c:varyColors val="0"/>
        <c:ser>
          <c:idx val="0"/>
          <c:order val="0"/>
          <c:tx>
            <c:v>48h</c:v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D$20,FIGURES!$H$20,FIGURES!$D$23,FIGURES!$H$23,FIGURES!$D$26,FIGURES!$H$26)</c:f>
                <c:numCache>
                  <c:formatCode>General</c:formatCode>
                  <c:ptCount val="6"/>
                  <c:pt idx="0">
                    <c:v>10.161279294704604</c:v>
                  </c:pt>
                  <c:pt idx="1">
                    <c:v>12.712702869169767</c:v>
                  </c:pt>
                  <c:pt idx="2">
                    <c:v>3.1072437190712807</c:v>
                  </c:pt>
                  <c:pt idx="3">
                    <c:v>4.430576105404981</c:v>
                  </c:pt>
                  <c:pt idx="4">
                    <c:v>7.9407272789605754</c:v>
                  </c:pt>
                  <c:pt idx="5">
                    <c:v>4.1618358314213459</c:v>
                  </c:pt>
                </c:numCache>
              </c:numRef>
            </c:plus>
            <c:minus>
              <c:numRef>
                <c:f>(FIGURES!$D$20,FIGURES!$H$20,FIGURES!$D$23,FIGURES!$H$23,FIGURES!$D$26,FIGURES!$H$26)</c:f>
                <c:numCache>
                  <c:formatCode>General</c:formatCode>
                  <c:ptCount val="6"/>
                  <c:pt idx="0">
                    <c:v>10.161279294704604</c:v>
                  </c:pt>
                  <c:pt idx="1">
                    <c:v>12.712702869169767</c:v>
                  </c:pt>
                  <c:pt idx="2">
                    <c:v>3.1072437190712807</c:v>
                  </c:pt>
                  <c:pt idx="3">
                    <c:v>4.430576105404981</c:v>
                  </c:pt>
                  <c:pt idx="4">
                    <c:v>7.9407272789605754</c:v>
                  </c:pt>
                  <c:pt idx="5">
                    <c:v>4.1618358314213459</c:v>
                  </c:pt>
                </c:numCache>
              </c:numRef>
            </c:minus>
          </c:errBars>
          <c:cat>
            <c:strRef>
              <c:f>FIGURES!$AC$2:$AC$7</c:f>
              <c:strCache>
                <c:ptCount val="6"/>
                <c:pt idx="0">
                  <c:v>KCNMA1-BS1</c:v>
                </c:pt>
                <c:pt idx="1">
                  <c:v>KCNMA1-BS2</c:v>
                </c:pt>
                <c:pt idx="2">
                  <c:v>M6PR-BS1</c:v>
                </c:pt>
                <c:pt idx="3">
                  <c:v>M6PR-BS2</c:v>
                </c:pt>
                <c:pt idx="4">
                  <c:v>SOX4-BS1</c:v>
                </c:pt>
                <c:pt idx="5">
                  <c:v>SOX4-BS2</c:v>
                </c:pt>
              </c:strCache>
            </c:strRef>
          </c:cat>
          <c:val>
            <c:numRef>
              <c:f>(FIGURES!$D$19,FIGURES!$H$19,FIGURES!$D$22,FIGURES!$H$22,FIGURES!$D$25,FIGURES!$H$25)</c:f>
              <c:numCache>
                <c:formatCode>0.0</c:formatCode>
                <c:ptCount val="6"/>
                <c:pt idx="0">
                  <c:v>82.203758579580636</c:v>
                </c:pt>
                <c:pt idx="1">
                  <c:v>82.031699585694525</c:v>
                </c:pt>
                <c:pt idx="2">
                  <c:v>74.198657065413101</c:v>
                </c:pt>
                <c:pt idx="3">
                  <c:v>73.202113370222932</c:v>
                </c:pt>
                <c:pt idx="4">
                  <c:v>64.718086172455855</c:v>
                </c:pt>
                <c:pt idx="5">
                  <c:v>66.4209344854129</c:v>
                </c:pt>
              </c:numCache>
            </c:numRef>
          </c:val>
        </c:ser>
        <c:ser>
          <c:idx val="1"/>
          <c:order val="1"/>
          <c:tx>
            <c:v>72h</c:v>
          </c:tx>
          <c:spPr>
            <a:solidFill>
              <a:schemeClr val="tx2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F$20,FIGURES!$J$20,FIGURES!$F$23,FIGURES!$J$23,FIGURES!$F$26,FIGURES!$J$26)</c:f>
                <c:numCache>
                  <c:formatCode>General</c:formatCode>
                  <c:ptCount val="6"/>
                  <c:pt idx="0">
                    <c:v>29.028825976480018</c:v>
                  </c:pt>
                  <c:pt idx="1">
                    <c:v>26.053630080302941</c:v>
                  </c:pt>
                  <c:pt idx="2">
                    <c:v>8.1838301201492776</c:v>
                  </c:pt>
                  <c:pt idx="3">
                    <c:v>7.4625761634298238</c:v>
                  </c:pt>
                  <c:pt idx="4">
                    <c:v>10.598348132701011</c:v>
                  </c:pt>
                  <c:pt idx="5">
                    <c:v>8.5043556554092508</c:v>
                  </c:pt>
                </c:numCache>
              </c:numRef>
            </c:plus>
            <c:minus>
              <c:numRef>
                <c:f>(FIGURES!$F$20,FIGURES!$J$20,FIGURES!$F$23,FIGURES!$J$23,FIGURES!$F$26,FIGURES!$J$26)</c:f>
                <c:numCache>
                  <c:formatCode>General</c:formatCode>
                  <c:ptCount val="6"/>
                  <c:pt idx="0">
                    <c:v>29.028825976480018</c:v>
                  </c:pt>
                  <c:pt idx="1">
                    <c:v>26.053630080302941</c:v>
                  </c:pt>
                  <c:pt idx="2">
                    <c:v>8.1838301201492776</c:v>
                  </c:pt>
                  <c:pt idx="3">
                    <c:v>7.4625761634298238</c:v>
                  </c:pt>
                  <c:pt idx="4">
                    <c:v>10.598348132701011</c:v>
                  </c:pt>
                  <c:pt idx="5">
                    <c:v>8.5043556554092508</c:v>
                  </c:pt>
                </c:numCache>
              </c:numRef>
            </c:minus>
          </c:errBars>
          <c:cat>
            <c:strRef>
              <c:f>FIGURES!$AC$2:$AC$7</c:f>
              <c:strCache>
                <c:ptCount val="6"/>
                <c:pt idx="0">
                  <c:v>KCNMA1-BS1</c:v>
                </c:pt>
                <c:pt idx="1">
                  <c:v>KCNMA1-BS2</c:v>
                </c:pt>
                <c:pt idx="2">
                  <c:v>M6PR-BS1</c:v>
                </c:pt>
                <c:pt idx="3">
                  <c:v>M6PR-BS2</c:v>
                </c:pt>
                <c:pt idx="4">
                  <c:v>SOX4-BS1</c:v>
                </c:pt>
                <c:pt idx="5">
                  <c:v>SOX4-BS2</c:v>
                </c:pt>
              </c:strCache>
            </c:strRef>
          </c:cat>
          <c:val>
            <c:numRef>
              <c:f>(FIGURES!$F$19,FIGURES!$J$19,FIGURES!$F$22,FIGURES!$J$22,FIGURES!$F$25,FIGURES!$J$25)</c:f>
              <c:numCache>
                <c:formatCode>0.0</c:formatCode>
                <c:ptCount val="6"/>
                <c:pt idx="0">
                  <c:v>70.342159698478127</c:v>
                </c:pt>
                <c:pt idx="1">
                  <c:v>70.996493393471553</c:v>
                </c:pt>
                <c:pt idx="2">
                  <c:v>85.343745283052939</c:v>
                </c:pt>
                <c:pt idx="3">
                  <c:v>83.253063576160685</c:v>
                </c:pt>
                <c:pt idx="4">
                  <c:v>73.960793591767796</c:v>
                </c:pt>
                <c:pt idx="5">
                  <c:v>76.1350338776006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076736"/>
        <c:axId val="97078272"/>
      </c:barChart>
      <c:catAx>
        <c:axId val="970767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585"/>
            </a:pPr>
            <a:endParaRPr lang="en-US"/>
          </a:p>
        </c:txPr>
        <c:crossAx val="97078272"/>
        <c:crosses val="autoZero"/>
        <c:auto val="1"/>
        <c:lblAlgn val="ctr"/>
        <c:lblOffset val="100"/>
        <c:noMultiLvlLbl val="0"/>
      </c:catAx>
      <c:valAx>
        <c:axId val="97078272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Luciferase Activity</a:t>
                </a:r>
                <a:r>
                  <a:rPr lang="en-US" sz="800" baseline="0"/>
                  <a:t> </a:t>
                </a:r>
                <a:r>
                  <a:rPr lang="en-US" sz="800"/>
                  <a:t>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7076736"/>
        <c:crosses val="autoZero"/>
        <c:crossBetween val="between"/>
        <c:majorUnit val="20"/>
      </c:valAx>
    </c:plotArea>
    <c:legend>
      <c:legendPos val="t"/>
      <c:layout>
        <c:manualLayout>
          <c:xMode val="edge"/>
          <c:yMode val="edge"/>
          <c:x val="0.41484601924759545"/>
          <c:y val="0.12962962962962868"/>
          <c:w val="0.17586351706036746"/>
          <c:h val="8.3717191601050026E-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48h</c:v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D$29,FIGURES!$H$29,FIGURES!$L$29)</c:f>
                <c:numCache>
                  <c:formatCode>General</c:formatCode>
                  <c:ptCount val="3"/>
                  <c:pt idx="0">
                    <c:v>2.3932788517360084</c:v>
                  </c:pt>
                  <c:pt idx="1">
                    <c:v>2.0876033224328716</c:v>
                  </c:pt>
                  <c:pt idx="2">
                    <c:v>4.2089762661214669</c:v>
                  </c:pt>
                </c:numCache>
              </c:numRef>
            </c:plus>
            <c:minus>
              <c:numRef>
                <c:f>(FIGURES!$D$29,FIGURES!$H$29,FIGURES!$L$29)</c:f>
                <c:numCache>
                  <c:formatCode>General</c:formatCode>
                  <c:ptCount val="3"/>
                  <c:pt idx="0">
                    <c:v>2.3932788517360084</c:v>
                  </c:pt>
                  <c:pt idx="1">
                    <c:v>2.0876033224328716</c:v>
                  </c:pt>
                  <c:pt idx="2">
                    <c:v>4.2089762661214669</c:v>
                  </c:pt>
                </c:numCache>
              </c:numRef>
            </c:minus>
          </c:errBars>
          <c:cat>
            <c:strRef>
              <c:f>FIGURES!$AC$10:$AC$12</c:f>
              <c:strCache>
                <c:ptCount val="3"/>
                <c:pt idx="0">
                  <c:v>BS1</c:v>
                </c:pt>
                <c:pt idx="1">
                  <c:v>BS2</c:v>
                </c:pt>
                <c:pt idx="2">
                  <c:v>BS3</c:v>
                </c:pt>
              </c:strCache>
            </c:strRef>
          </c:cat>
          <c:val>
            <c:numRef>
              <c:f>(FIGURES!$D$28,FIGURES!$H$28,FIGURES!$L$28)</c:f>
              <c:numCache>
                <c:formatCode>0.0</c:formatCode>
                <c:ptCount val="3"/>
                <c:pt idx="0">
                  <c:v>80.724952534410889</c:v>
                </c:pt>
                <c:pt idx="1">
                  <c:v>67.856649118333209</c:v>
                </c:pt>
                <c:pt idx="2">
                  <c:v>73.913223095173024</c:v>
                </c:pt>
              </c:numCache>
            </c:numRef>
          </c:val>
        </c:ser>
        <c:ser>
          <c:idx val="1"/>
          <c:order val="1"/>
          <c:tx>
            <c:v>72h</c:v>
          </c:tx>
          <c:spPr>
            <a:solidFill>
              <a:schemeClr val="tx2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IGURES!$F$29,FIGURES!$J$29,FIGURES!$N$29)</c:f>
                <c:numCache>
                  <c:formatCode>General</c:formatCode>
                  <c:ptCount val="3"/>
                  <c:pt idx="0">
                    <c:v>8.0852904834909669</c:v>
                  </c:pt>
                  <c:pt idx="1">
                    <c:v>12.733623523775618</c:v>
                  </c:pt>
                  <c:pt idx="2">
                    <c:v>14.318183537756974</c:v>
                  </c:pt>
                </c:numCache>
              </c:numRef>
            </c:plus>
            <c:minus>
              <c:numRef>
                <c:f>(FIGURES!$F$29,FIGURES!$J$29,FIGURES!$N$29)</c:f>
                <c:numCache>
                  <c:formatCode>General</c:formatCode>
                  <c:ptCount val="3"/>
                  <c:pt idx="0">
                    <c:v>8.0852904834909669</c:v>
                  </c:pt>
                  <c:pt idx="1">
                    <c:v>12.733623523775618</c:v>
                  </c:pt>
                  <c:pt idx="2">
                    <c:v>14.318183537756974</c:v>
                  </c:pt>
                </c:numCache>
              </c:numRef>
            </c:minus>
          </c:errBars>
          <c:cat>
            <c:strRef>
              <c:f>FIGURES!$AC$10:$AC$12</c:f>
              <c:strCache>
                <c:ptCount val="3"/>
                <c:pt idx="0">
                  <c:v>BS1</c:v>
                </c:pt>
                <c:pt idx="1">
                  <c:v>BS2</c:v>
                </c:pt>
                <c:pt idx="2">
                  <c:v>BS3</c:v>
                </c:pt>
              </c:strCache>
            </c:strRef>
          </c:cat>
          <c:val>
            <c:numRef>
              <c:f>(FIGURES!$F$28,FIGURES!$J$28,FIGURES!$N$28)</c:f>
              <c:numCache>
                <c:formatCode>0.0</c:formatCode>
                <c:ptCount val="3"/>
                <c:pt idx="0">
                  <c:v>72.351877581513818</c:v>
                </c:pt>
                <c:pt idx="1">
                  <c:v>73.998052316272648</c:v>
                </c:pt>
                <c:pt idx="2">
                  <c:v>70.0695497721852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70"/>
        <c:axId val="103457152"/>
        <c:axId val="103641472"/>
      </c:barChart>
      <c:catAx>
        <c:axId val="1034571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3641472"/>
        <c:crosses val="autoZero"/>
        <c:auto val="1"/>
        <c:lblAlgn val="ctr"/>
        <c:lblOffset val="100"/>
        <c:noMultiLvlLbl val="0"/>
      </c:catAx>
      <c:valAx>
        <c:axId val="103641472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Luciferase Activity</a:t>
                </a:r>
                <a:r>
                  <a:rPr lang="en-US" sz="800" baseline="0"/>
                  <a:t> </a:t>
                </a:r>
                <a:r>
                  <a:rPr lang="en-US" sz="800"/>
                  <a:t>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3457152"/>
        <c:crosses val="autoZero"/>
        <c:crossBetween val="between"/>
        <c:majorUnit val="20"/>
      </c:valAx>
    </c:plotArea>
    <c:legend>
      <c:legendPos val="t"/>
      <c:layout>
        <c:manualLayout>
          <c:xMode val="edge"/>
          <c:yMode val="edge"/>
          <c:x val="0.41484601924759568"/>
          <c:y val="0.12962962962962857"/>
          <c:w val="0.17586351706036746"/>
          <c:h val="8.3717191601050026E-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1D7E5-407B-467F-9C84-9C552A6C4E7B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66AC25-740B-41FB-9D8A-032707FEA2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/>
          <p:cNvGrpSpPr/>
          <p:nvPr/>
        </p:nvGrpSpPr>
        <p:grpSpPr>
          <a:xfrm>
            <a:off x="1850354" y="520496"/>
            <a:ext cx="3263189" cy="7860373"/>
            <a:chOff x="1850354" y="520496"/>
            <a:chExt cx="3263189" cy="7860373"/>
          </a:xfrm>
        </p:grpSpPr>
        <p:grpSp>
          <p:nvGrpSpPr>
            <p:cNvPr id="78" name="Group 77"/>
            <p:cNvGrpSpPr/>
            <p:nvPr/>
          </p:nvGrpSpPr>
          <p:grpSpPr>
            <a:xfrm>
              <a:off x="1850354" y="520496"/>
              <a:ext cx="3144352" cy="2489150"/>
              <a:chOff x="277586" y="971600"/>
              <a:chExt cx="3144352" cy="2489150"/>
            </a:xfrm>
          </p:grpSpPr>
          <p:grpSp>
            <p:nvGrpSpPr>
              <p:cNvPr id="97" name="Group 96"/>
              <p:cNvGrpSpPr/>
              <p:nvPr/>
            </p:nvGrpSpPr>
            <p:grpSpPr>
              <a:xfrm>
                <a:off x="277586" y="971600"/>
                <a:ext cx="3144352" cy="2376264"/>
                <a:chOff x="277586" y="1107474"/>
                <a:chExt cx="3144352" cy="2903436"/>
              </a:xfrm>
            </p:grpSpPr>
            <p:graphicFrame>
              <p:nvGraphicFramePr>
                <p:cNvPr id="62" name="Chart 61"/>
                <p:cNvGraphicFramePr/>
                <p:nvPr>
                  <p:extLst>
                    <p:ext uri="{D42A27DB-BD31-4B8C-83A1-F6EECF244321}">
                      <p14:modId xmlns:p14="http://schemas.microsoft.com/office/powerpoint/2010/main" val="2687732848"/>
                    </p:ext>
                  </p:extLst>
                </p:nvPr>
              </p:nvGraphicFramePr>
              <p:xfrm>
                <a:off x="277586" y="1107474"/>
                <a:ext cx="3144352" cy="290343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68" name="TextBox 67"/>
                <p:cNvSpPr txBox="1"/>
                <p:nvPr/>
              </p:nvSpPr>
              <p:spPr>
                <a:xfrm>
                  <a:off x="1052736" y="2195736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818710" y="1954257"/>
                  <a:ext cx="2394266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  <a:prstDash val="lgDashDot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TextBox 72"/>
                <p:cNvSpPr txBox="1"/>
                <p:nvPr/>
              </p:nvSpPr>
              <p:spPr>
                <a:xfrm>
                  <a:off x="1844824" y="2267744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1124744" y="2051720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*</a:t>
                  </a:r>
                  <a:endParaRPr lang="en-US" sz="700" dirty="0"/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2636912" y="2483768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708920" y="2411760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1916832" y="2267744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</p:grpSp>
          <p:sp>
            <p:nvSpPr>
              <p:cNvPr id="40" name="Rectangle 39"/>
              <p:cNvSpPr/>
              <p:nvPr/>
            </p:nvSpPr>
            <p:spPr>
              <a:xfrm>
                <a:off x="996950" y="3162300"/>
                <a:ext cx="2089150" cy="2984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965200" y="3079750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SSRP1</a:t>
                </a:r>
                <a:endParaRPr lang="en-US" sz="1200" b="1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784350" y="3086100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PDE3A</a:t>
                </a:r>
                <a:endParaRPr lang="en-US" sz="12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559050" y="30861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LIFR</a:t>
                </a:r>
                <a:endParaRPr lang="en-US" sz="1200" b="1" dirty="0"/>
              </a:p>
            </p:txBody>
          </p:sp>
        </p:grpSp>
        <p:grpSp>
          <p:nvGrpSpPr>
            <p:cNvPr id="70" name="Group 69"/>
            <p:cNvGrpSpPr/>
            <p:nvPr/>
          </p:nvGrpSpPr>
          <p:grpSpPr>
            <a:xfrm>
              <a:off x="1850354" y="3019857"/>
              <a:ext cx="3263189" cy="2651848"/>
              <a:chOff x="3436061" y="971601"/>
              <a:chExt cx="3263189" cy="2651848"/>
            </a:xfrm>
          </p:grpSpPr>
          <p:grpSp>
            <p:nvGrpSpPr>
              <p:cNvPr id="98" name="Group 97"/>
              <p:cNvGrpSpPr/>
              <p:nvPr/>
            </p:nvGrpSpPr>
            <p:grpSpPr>
              <a:xfrm>
                <a:off x="3436061" y="971601"/>
                <a:ext cx="3144352" cy="2304256"/>
                <a:chOff x="3436061" y="1107475"/>
                <a:chExt cx="3144352" cy="2903436"/>
              </a:xfrm>
            </p:grpSpPr>
            <p:graphicFrame>
              <p:nvGraphicFramePr>
                <p:cNvPr id="64" name="Chart 63"/>
                <p:cNvGraphicFramePr/>
                <p:nvPr>
                  <p:extLst>
                    <p:ext uri="{D42A27DB-BD31-4B8C-83A1-F6EECF244321}">
                      <p14:modId xmlns:p14="http://schemas.microsoft.com/office/powerpoint/2010/main" val="3789516173"/>
                    </p:ext>
                  </p:extLst>
                </p:nvPr>
              </p:nvGraphicFramePr>
              <p:xfrm>
                <a:off x="3436061" y="1107475"/>
                <a:ext cx="3144352" cy="290343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cxnSp>
              <p:nvCxnSpPr>
                <p:cNvPr id="71" name="Straight Connector 70"/>
                <p:cNvCxnSpPr/>
                <p:nvPr/>
              </p:nvCxnSpPr>
              <p:spPr>
                <a:xfrm>
                  <a:off x="3987062" y="1907704"/>
                  <a:ext cx="2394266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  <a:prstDash val="lgDashDot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>
                  <a:off x="5229200" y="2155730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4077072" y="1723682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933056" y="1851665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4509120" y="1763688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4869160" y="1835696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5301208" y="1907704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5733256" y="1979712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6148288" y="1979701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4797152" y="2155730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6025604" y="2243749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5661248" y="2243707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4437112" y="1779657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</p:grpSp>
          <p:sp>
            <p:nvSpPr>
              <p:cNvPr id="47" name="Rectangle 46"/>
              <p:cNvSpPr/>
              <p:nvPr/>
            </p:nvSpPr>
            <p:spPr>
              <a:xfrm>
                <a:off x="3956050" y="3098800"/>
                <a:ext cx="2743200" cy="2032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994150" y="30607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1</a:t>
                </a:r>
                <a:endParaRPr lang="en-US" sz="120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419600" y="30607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2</a:t>
                </a:r>
                <a:endParaRPr lang="en-US" sz="12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832350" y="306705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1</a:t>
                </a:r>
                <a:endParaRPr lang="en-US" sz="12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257800" y="306705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2</a:t>
                </a:r>
                <a:endParaRPr lang="en-US" sz="12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645150" y="30607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1</a:t>
                </a:r>
                <a:endParaRPr lang="en-US" sz="12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6070600" y="30607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2</a:t>
                </a:r>
                <a:endParaRPr lang="en-US" sz="1200" dirty="0"/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4816202" y="1619672"/>
                <a:ext cx="3448" cy="182202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H="1">
                <a:off x="5626100" y="1619672"/>
                <a:ext cx="7590" cy="182202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>
                <a:off x="4044950" y="3346450"/>
                <a:ext cx="7528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KCNMA1</a:t>
                </a:r>
                <a:endParaRPr lang="en-US" sz="1200" b="1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959350" y="3346450"/>
                <a:ext cx="5661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M6PR</a:t>
                </a:r>
                <a:endParaRPr lang="en-US" sz="1200" b="1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759450" y="3346450"/>
                <a:ext cx="5192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SOX4</a:t>
                </a:r>
                <a:endParaRPr lang="en-US" sz="1200" b="1" dirty="0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1850354" y="5883032"/>
              <a:ext cx="3144352" cy="2497837"/>
              <a:chOff x="1770782" y="3932312"/>
              <a:chExt cx="3144352" cy="2497837"/>
            </a:xfrm>
          </p:grpSpPr>
          <p:grpSp>
            <p:nvGrpSpPr>
              <p:cNvPr id="105" name="Group 104"/>
              <p:cNvGrpSpPr/>
              <p:nvPr/>
            </p:nvGrpSpPr>
            <p:grpSpPr>
              <a:xfrm>
                <a:off x="1770782" y="3932312"/>
                <a:ext cx="3144352" cy="2232247"/>
                <a:chOff x="1844824" y="4067944"/>
                <a:chExt cx="3144352" cy="2903435"/>
              </a:xfrm>
            </p:grpSpPr>
            <p:graphicFrame>
              <p:nvGraphicFramePr>
                <p:cNvPr id="66" name="Chart 65"/>
                <p:cNvGraphicFramePr/>
                <p:nvPr>
                  <p:extLst>
                    <p:ext uri="{D42A27DB-BD31-4B8C-83A1-F6EECF244321}">
                      <p14:modId xmlns:p14="http://schemas.microsoft.com/office/powerpoint/2010/main" val="2538218004"/>
                    </p:ext>
                  </p:extLst>
                </p:nvPr>
              </p:nvGraphicFramePr>
              <p:xfrm>
                <a:off x="1844824" y="4067944"/>
                <a:ext cx="3144352" cy="290343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cxnSp>
              <p:nvCxnSpPr>
                <p:cNvPr id="72" name="Straight Connector 71"/>
                <p:cNvCxnSpPr/>
                <p:nvPr/>
              </p:nvCxnSpPr>
              <p:spPr>
                <a:xfrm>
                  <a:off x="2402886" y="4942625"/>
                  <a:ext cx="2394266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  <a:prstDash val="lgDashDot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TextBox 98"/>
                <p:cNvSpPr txBox="1"/>
                <p:nvPr/>
              </p:nvSpPr>
              <p:spPr>
                <a:xfrm>
                  <a:off x="2636912" y="5020017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2708920" y="5076056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3573016" y="4948009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/>
                    <a:t>*</a:t>
                  </a:r>
                  <a:endParaRPr lang="en-US" sz="700" dirty="0"/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4221088" y="5092025"/>
                  <a:ext cx="360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smtClean="0"/>
                    <a:t>***</a:t>
                  </a:r>
                  <a:endParaRPr lang="en-US" sz="700" dirty="0"/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3429000" y="5292080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**</a:t>
                  </a:r>
                  <a:endParaRPr lang="en-US" sz="700" dirty="0"/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4365104" y="4932040"/>
                  <a:ext cx="28803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 smtClean="0"/>
                    <a:t>ns</a:t>
                  </a:r>
                  <a:endParaRPr lang="en-US" sz="700" dirty="0"/>
                </a:p>
              </p:txBody>
            </p:sp>
          </p:grpSp>
          <p:sp>
            <p:nvSpPr>
              <p:cNvPr id="46" name="Rectangle 45"/>
              <p:cNvSpPr/>
              <p:nvPr/>
            </p:nvSpPr>
            <p:spPr>
              <a:xfrm>
                <a:off x="2565400" y="5975350"/>
                <a:ext cx="2089150" cy="1397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546350" y="58928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1</a:t>
                </a:r>
                <a:endParaRPr lang="en-US" sz="120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321050" y="58928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2</a:t>
                </a:r>
                <a:endParaRPr lang="en-US" sz="1200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4184650" y="5892800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/>
                  <a:t>BS3</a:t>
                </a:r>
                <a:endParaRPr lang="en-US" sz="1200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3232150" y="6153150"/>
                <a:ext cx="5977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/>
                  <a:t>SOX11</a:t>
                </a:r>
                <a:endParaRPr lang="en-US" sz="1200" b="1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214372" y="3989324"/>
                <a:ext cx="2152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Target with 3 Binding Sites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64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s</dc:creator>
  <cp:lastModifiedBy>Christiane MARGUE</cp:lastModifiedBy>
  <cp:revision>25</cp:revision>
  <dcterms:created xsi:type="dcterms:W3CDTF">2012-06-17T14:58:32Z</dcterms:created>
  <dcterms:modified xsi:type="dcterms:W3CDTF">2013-03-12T09:18:16Z</dcterms:modified>
</cp:coreProperties>
</file>